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>
        <p:scale>
          <a:sx n="100" d="100"/>
          <a:sy n="100" d="100"/>
        </p:scale>
        <p:origin x="-2172" y="6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\\soton.ac.uk\ude\personalfiles\users\mvh1m13\mydesktop\Vicky%20H\STRUCTURE%20-%20Jeremy\Lysozyme\Paper%20draft\RESULTS%20-%20Antisera%20soluble%20ACPI%20(+controls)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\\soton.ac.uk\ude\personalfiles\users\mvh1m13\mydesktop\Vicky%20H\STRUCTURE%20-%20Jeremy\Lysozyme\Paper%20draft\RESULTS%20-%20Antisera%20soluble%20ACPII%20(+controls)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 anchor="b" anchorCtr="1"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GB" sz="1200" i="0" dirty="0" err="1">
                <a:latin typeface="Arial" panose="020B0604020202020204" pitchFamily="34" charset="0"/>
                <a:cs typeface="Arial" panose="020B0604020202020204" pitchFamily="34" charset="0"/>
              </a:rPr>
              <a:t>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ACPI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mmunisa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822970870909798"/>
          <c:y val="4.6376676303358795E-2"/>
          <c:w val="0.57740782578100402"/>
          <c:h val="0.69557741119658389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A$52</c:f>
              <c:strCache>
                <c:ptCount val="1"/>
                <c:pt idx="0">
                  <c:v>Salin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oja1!$B$60:$E$60</c:f>
                <c:numCache>
                  <c:formatCode>General</c:formatCode>
                  <c:ptCount val="4"/>
                  <c:pt idx="0">
                    <c:v>0.3963146214576358</c:v>
                  </c:pt>
                  <c:pt idx="1">
                    <c:v>0.35475138477390855</c:v>
                  </c:pt>
                  <c:pt idx="2">
                    <c:v>0.60898263845098954</c:v>
                  </c:pt>
                  <c:pt idx="3">
                    <c:v>0.28630424739965454</c:v>
                  </c:pt>
                </c:numCache>
              </c:numRef>
            </c:plus>
            <c:minus>
              <c:numRef>
                <c:f>Hoja1!$B$60:$E$60</c:f>
                <c:numCache>
                  <c:formatCode>General</c:formatCode>
                  <c:ptCount val="4"/>
                  <c:pt idx="0">
                    <c:v>0.3963146214576358</c:v>
                  </c:pt>
                  <c:pt idx="1">
                    <c:v>0.35475138477390855</c:v>
                  </c:pt>
                  <c:pt idx="2">
                    <c:v>0.60898263845098954</c:v>
                  </c:pt>
                  <c:pt idx="3">
                    <c:v>0.28630424739965454</c:v>
                  </c:pt>
                </c:numCache>
              </c:numRef>
            </c:minus>
          </c:errBars>
          <c:cat>
            <c:strRef>
              <c:f>Hoja1!$B$51:$E$51</c:f>
              <c:strCache>
                <c:ptCount val="4"/>
                <c:pt idx="0">
                  <c:v>rNm-ACPI</c:v>
                </c:pt>
                <c:pt idx="1">
                  <c:v>rNm-ACPII</c:v>
                </c:pt>
                <c:pt idx="2">
                  <c:v>MC58-OM (Nm-ACPI)</c:v>
                </c:pt>
                <c:pt idx="3">
                  <c:v>MC161-OM (Nm-ACPII)</c:v>
                </c:pt>
              </c:strCache>
            </c:strRef>
          </c:cat>
          <c:val>
            <c:numRef>
              <c:f>Hoja1!$B$52:$E$52</c:f>
              <c:numCache>
                <c:formatCode>General</c:formatCode>
                <c:ptCount val="4"/>
                <c:pt idx="0">
                  <c:v>2.7588864770046091</c:v>
                </c:pt>
                <c:pt idx="1">
                  <c:v>2.7321380935087425</c:v>
                </c:pt>
                <c:pt idx="2">
                  <c:v>2.1168006444071135</c:v>
                </c:pt>
                <c:pt idx="3">
                  <c:v>2.7172348557499437</c:v>
                </c:pt>
              </c:numCache>
            </c:numRef>
          </c:val>
        </c:ser>
        <c:ser>
          <c:idx val="1"/>
          <c:order val="1"/>
          <c:tx>
            <c:strRef>
              <c:f>Hoja1!$A$53</c:f>
              <c:strCache>
                <c:ptCount val="1"/>
                <c:pt idx="0">
                  <c:v>Al(OH)3</c:v>
                </c:pt>
              </c:strCache>
            </c:strRef>
          </c:tx>
          <c:spPr>
            <a:solidFill>
              <a:schemeClr val="bg1"/>
            </a:solidFill>
            <a:ln w="9525"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oja1!$B$61:$E$61</c:f>
                <c:numCache>
                  <c:formatCode>General</c:formatCode>
                  <c:ptCount val="4"/>
                  <c:pt idx="0">
                    <c:v>0.89851913062262267</c:v>
                  </c:pt>
                  <c:pt idx="1">
                    <c:v>0.47417814021534432</c:v>
                  </c:pt>
                  <c:pt idx="2">
                    <c:v>0.16770977084415192</c:v>
                  </c:pt>
                  <c:pt idx="3">
                    <c:v>0.1865105318419886</c:v>
                  </c:pt>
                </c:numCache>
              </c:numRef>
            </c:plus>
            <c:minus>
              <c:numRef>
                <c:f>Hoja1!$B$61:$E$61</c:f>
                <c:numCache>
                  <c:formatCode>General</c:formatCode>
                  <c:ptCount val="4"/>
                  <c:pt idx="0">
                    <c:v>0.89851913062262267</c:v>
                  </c:pt>
                  <c:pt idx="1">
                    <c:v>0.47417814021534432</c:v>
                  </c:pt>
                  <c:pt idx="2">
                    <c:v>0.16770977084415192</c:v>
                  </c:pt>
                  <c:pt idx="3">
                    <c:v>0.1865105318419886</c:v>
                  </c:pt>
                </c:numCache>
              </c:numRef>
            </c:minus>
          </c:errBars>
          <c:cat>
            <c:strRef>
              <c:f>Hoja1!$B$51:$E$51</c:f>
              <c:strCache>
                <c:ptCount val="4"/>
                <c:pt idx="0">
                  <c:v>rNm-ACPI</c:v>
                </c:pt>
                <c:pt idx="1">
                  <c:v>rNm-ACPII</c:v>
                </c:pt>
                <c:pt idx="2">
                  <c:v>MC58-OM (Nm-ACPI)</c:v>
                </c:pt>
                <c:pt idx="3">
                  <c:v>MC161-OM (Nm-ACPII)</c:v>
                </c:pt>
              </c:strCache>
            </c:strRef>
          </c:cat>
          <c:val>
            <c:numRef>
              <c:f>Hoja1!$B$53:$E$53</c:f>
              <c:numCache>
                <c:formatCode>General</c:formatCode>
                <c:ptCount val="4"/>
                <c:pt idx="0">
                  <c:v>6.1700386290638072</c:v>
                </c:pt>
                <c:pt idx="1">
                  <c:v>6.7158734359458556</c:v>
                </c:pt>
                <c:pt idx="2">
                  <c:v>4.5979910442482668</c:v>
                </c:pt>
                <c:pt idx="3">
                  <c:v>4.7233824574370855</c:v>
                </c:pt>
              </c:numCache>
            </c:numRef>
          </c:val>
        </c:ser>
        <c:ser>
          <c:idx val="2"/>
          <c:order val="2"/>
          <c:tx>
            <c:strRef>
              <c:f>Hoja1!$A$54</c:f>
              <c:strCache>
                <c:ptCount val="1"/>
                <c:pt idx="0">
                  <c:v>Liposomes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oja1!$B$62:$E$62</c:f>
                <c:numCache>
                  <c:formatCode>General</c:formatCode>
                  <c:ptCount val="4"/>
                  <c:pt idx="0">
                    <c:v>0.26602107991159157</c:v>
                  </c:pt>
                  <c:pt idx="1">
                    <c:v>0.17178371475954257</c:v>
                  </c:pt>
                  <c:pt idx="2">
                    <c:v>0.445565779130283</c:v>
                  </c:pt>
                  <c:pt idx="3">
                    <c:v>0.60424698755750184</c:v>
                  </c:pt>
                </c:numCache>
              </c:numRef>
            </c:plus>
            <c:minus>
              <c:numRef>
                <c:f>Hoja1!$B$62:$E$62</c:f>
                <c:numCache>
                  <c:formatCode>General</c:formatCode>
                  <c:ptCount val="4"/>
                  <c:pt idx="0">
                    <c:v>0.26602107991159157</c:v>
                  </c:pt>
                  <c:pt idx="1">
                    <c:v>0.17178371475954257</c:v>
                  </c:pt>
                  <c:pt idx="2">
                    <c:v>0.445565779130283</c:v>
                  </c:pt>
                  <c:pt idx="3">
                    <c:v>0.60424698755750184</c:v>
                  </c:pt>
                </c:numCache>
              </c:numRef>
            </c:minus>
          </c:errBars>
          <c:cat>
            <c:strRef>
              <c:f>Hoja1!$B$51:$E$51</c:f>
              <c:strCache>
                <c:ptCount val="4"/>
                <c:pt idx="0">
                  <c:v>rNm-ACPI</c:v>
                </c:pt>
                <c:pt idx="1">
                  <c:v>rNm-ACPII</c:v>
                </c:pt>
                <c:pt idx="2">
                  <c:v>MC58-OM (Nm-ACPI)</c:v>
                </c:pt>
                <c:pt idx="3">
                  <c:v>MC161-OM (Nm-ACPII)</c:v>
                </c:pt>
              </c:strCache>
            </c:strRef>
          </c:cat>
          <c:val>
            <c:numRef>
              <c:f>Hoja1!$B$54:$E$54</c:f>
              <c:numCache>
                <c:formatCode>General</c:formatCode>
                <c:ptCount val="4"/>
                <c:pt idx="0">
                  <c:v>5.7562773135315073</c:v>
                </c:pt>
                <c:pt idx="1">
                  <c:v>6.0832224460846103</c:v>
                </c:pt>
                <c:pt idx="2">
                  <c:v>4.3177467263436009</c:v>
                </c:pt>
                <c:pt idx="3">
                  <c:v>4.69126320025953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187280000"/>
        <c:axId val="187285888"/>
      </c:barChart>
      <c:catAx>
        <c:axId val="187280000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285888"/>
        <c:crosses val="autoZero"/>
        <c:auto val="1"/>
        <c:lblAlgn val="ctr"/>
        <c:lblOffset val="100"/>
        <c:noMultiLvlLbl val="0"/>
      </c:catAx>
      <c:valAx>
        <c:axId val="187285888"/>
        <c:scaling>
          <c:orientation val="minMax"/>
          <c:max val="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AR" sz="110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s-AR" sz="1100" baseline="-2500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s-AR" sz="1100">
                    <a:latin typeface="Arial" panose="020B0604020202020204" pitchFamily="34" charset="0"/>
                    <a:cs typeface="Arial" panose="020B0604020202020204" pitchFamily="34" charset="0"/>
                  </a:rPr>
                  <a:t> Geomean reciprocal ELISA titre</a:t>
                </a:r>
                <a:endParaRPr lang="en-GB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AR" sz="1100">
                    <a:latin typeface="Arial" panose="020B0604020202020204" pitchFamily="34" charset="0"/>
                    <a:cs typeface="Arial" panose="020B0604020202020204" pitchFamily="34" charset="0"/>
                  </a:rPr>
                  <a:t>(± 95% confidence limits)</a:t>
                </a:r>
                <a:endParaRPr lang="en-GB" sz="110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280000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26662608099850005"/>
          <c:y val="0.84695842859302772"/>
          <c:w val="0.48267145706707987"/>
          <c:h val="6.2177659183478867E-2"/>
        </c:manualLayout>
      </c:layout>
      <c:overlay val="0"/>
      <c:txPr>
        <a:bodyPr/>
        <a:lstStyle/>
        <a:p>
          <a:pPr>
            <a:defRPr sz="900"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GB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title>
      <c:tx>
        <c:rich>
          <a:bodyPr/>
          <a:lstStyle/>
          <a:p>
            <a:pPr>
              <a:defRPr sz="1200">
                <a:latin typeface="Arial" panose="020B0604020202020204" pitchFamily="34" charset="0"/>
                <a:cs typeface="Arial" panose="020B0604020202020204" pitchFamily="34" charset="0"/>
              </a:defRPr>
            </a:pPr>
            <a:r>
              <a:rPr lang="en-GB" sz="1200" dirty="0" err="1">
                <a:latin typeface="Arial" panose="020B0604020202020204" pitchFamily="34" charset="0"/>
                <a:cs typeface="Arial" panose="020B0604020202020204" pitchFamily="34" charset="0"/>
              </a:rPr>
              <a:t>rNm</a:t>
            </a:r>
            <a:r>
              <a:rPr lang="en-GB" sz="1200" dirty="0">
                <a:latin typeface="Arial" panose="020B0604020202020204" pitchFamily="34" charset="0"/>
                <a:cs typeface="Arial" panose="020B0604020202020204" pitchFamily="34" charset="0"/>
              </a:rPr>
              <a:t>-ACPII </a:t>
            </a:r>
            <a:r>
              <a:rPr lang="en-GB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immunisation</a:t>
            </a:r>
            <a:endParaRPr lang="en-GB" sz="1200" dirty="0">
              <a:latin typeface="Arial" panose="020B0604020202020204" pitchFamily="34" charset="0"/>
              <a:cs typeface="Arial" panose="020B0604020202020204" pitchFamily="34" charset="0"/>
            </a:endParaRPr>
          </a:p>
        </c:rich>
      </c:tx>
      <c:layout/>
      <c:overlay val="1"/>
    </c:title>
    <c:autoTitleDeleted val="0"/>
    <c:plotArea>
      <c:layout>
        <c:manualLayout>
          <c:layoutTarget val="inner"/>
          <c:xMode val="edge"/>
          <c:yMode val="edge"/>
          <c:x val="0.18230046296296296"/>
          <c:y val="4.6379438717067581E-2"/>
          <c:w val="0.60760995370370374"/>
          <c:h val="0.6955592783505154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Hoja1!$A$52</c:f>
              <c:strCache>
                <c:ptCount val="1"/>
                <c:pt idx="0">
                  <c:v>Saline</c:v>
                </c:pt>
              </c:strCache>
            </c:strRef>
          </c:tx>
          <c:spPr>
            <a:solidFill>
              <a:schemeClr val="tx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oja1!$B$60:$E$60</c:f>
                <c:numCache>
                  <c:formatCode>General</c:formatCode>
                  <c:ptCount val="4"/>
                  <c:pt idx="0">
                    <c:v>9.9896594140186937E-2</c:v>
                  </c:pt>
                  <c:pt idx="1">
                    <c:v>0.26499527476007734</c:v>
                  </c:pt>
                  <c:pt idx="2">
                    <c:v>0.17900202341570967</c:v>
                  </c:pt>
                  <c:pt idx="3">
                    <c:v>0.19048069047215865</c:v>
                  </c:pt>
                </c:numCache>
              </c:numRef>
            </c:plus>
            <c:minus>
              <c:numRef>
                <c:f>Hoja1!$B$60:$E$60</c:f>
                <c:numCache>
                  <c:formatCode>General</c:formatCode>
                  <c:ptCount val="4"/>
                  <c:pt idx="0">
                    <c:v>9.9896594140186937E-2</c:v>
                  </c:pt>
                  <c:pt idx="1">
                    <c:v>0.26499527476007734</c:v>
                  </c:pt>
                  <c:pt idx="2">
                    <c:v>0.17900202341570967</c:v>
                  </c:pt>
                  <c:pt idx="3">
                    <c:v>0.19048069047215865</c:v>
                  </c:pt>
                </c:numCache>
              </c:numRef>
            </c:minus>
          </c:errBars>
          <c:cat>
            <c:strRef>
              <c:f>Hoja1!$B$51:$E$51</c:f>
              <c:strCache>
                <c:ptCount val="4"/>
                <c:pt idx="0">
                  <c:v>rNm-ACPI</c:v>
                </c:pt>
                <c:pt idx="1">
                  <c:v>rNm-ACPII</c:v>
                </c:pt>
                <c:pt idx="2">
                  <c:v>MC58-OM (Nm-ACPI)</c:v>
                </c:pt>
                <c:pt idx="3">
                  <c:v>MC161-OM (Nm-ACPII)</c:v>
                </c:pt>
              </c:strCache>
            </c:strRef>
          </c:cat>
          <c:val>
            <c:numRef>
              <c:f>Hoja1!$B$52:$E$52</c:f>
              <c:numCache>
                <c:formatCode>General</c:formatCode>
                <c:ptCount val="4"/>
                <c:pt idx="0">
                  <c:v>2.6011442191028307</c:v>
                </c:pt>
                <c:pt idx="1">
                  <c:v>3.2338930379993807</c:v>
                </c:pt>
                <c:pt idx="2">
                  <c:v>2.7632201894603492</c:v>
                </c:pt>
                <c:pt idx="3">
                  <c:v>2.7891055374078291</c:v>
                </c:pt>
              </c:numCache>
            </c:numRef>
          </c:val>
        </c:ser>
        <c:ser>
          <c:idx val="1"/>
          <c:order val="1"/>
          <c:tx>
            <c:strRef>
              <c:f>Hoja1!$A$53</c:f>
              <c:strCache>
                <c:ptCount val="1"/>
                <c:pt idx="0">
                  <c:v>Al(OH)3</c:v>
                </c:pt>
              </c:strCache>
            </c:strRef>
          </c:tx>
          <c:spPr>
            <a:solidFill>
              <a:schemeClr val="bg1"/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oja1!$B$61:$E$61</c:f>
                <c:numCache>
                  <c:formatCode>General</c:formatCode>
                  <c:ptCount val="4"/>
                  <c:pt idx="0">
                    <c:v>0.42971348296709871</c:v>
                  </c:pt>
                  <c:pt idx="1">
                    <c:v>0.55087859088486557</c:v>
                  </c:pt>
                  <c:pt idx="2">
                    <c:v>0.3181501419494227</c:v>
                  </c:pt>
                  <c:pt idx="3">
                    <c:v>0.39940687313729484</c:v>
                  </c:pt>
                </c:numCache>
              </c:numRef>
            </c:plus>
            <c:minus>
              <c:numRef>
                <c:f>Hoja1!$B$61:$E$61</c:f>
                <c:numCache>
                  <c:formatCode>General</c:formatCode>
                  <c:ptCount val="4"/>
                  <c:pt idx="0">
                    <c:v>0.42971348296709871</c:v>
                  </c:pt>
                  <c:pt idx="1">
                    <c:v>0.55087859088486557</c:v>
                  </c:pt>
                  <c:pt idx="2">
                    <c:v>0.3181501419494227</c:v>
                  </c:pt>
                  <c:pt idx="3">
                    <c:v>0.39940687313729484</c:v>
                  </c:pt>
                </c:numCache>
              </c:numRef>
            </c:minus>
          </c:errBars>
          <c:cat>
            <c:strRef>
              <c:f>Hoja1!$B$51:$E$51</c:f>
              <c:strCache>
                <c:ptCount val="4"/>
                <c:pt idx="0">
                  <c:v>rNm-ACPI</c:v>
                </c:pt>
                <c:pt idx="1">
                  <c:v>rNm-ACPII</c:v>
                </c:pt>
                <c:pt idx="2">
                  <c:v>MC58-OM (Nm-ACPI)</c:v>
                </c:pt>
                <c:pt idx="3">
                  <c:v>MC161-OM (Nm-ACPII)</c:v>
                </c:pt>
              </c:strCache>
            </c:strRef>
          </c:cat>
          <c:val>
            <c:numRef>
              <c:f>Hoja1!$B$53:$E$53</c:f>
              <c:numCache>
                <c:formatCode>General</c:formatCode>
                <c:ptCount val="4"/>
                <c:pt idx="0">
                  <c:v>6.4155634362586307</c:v>
                </c:pt>
                <c:pt idx="1">
                  <c:v>7.0004158215117274</c:v>
                </c:pt>
                <c:pt idx="2">
                  <c:v>4.4460480713069384</c:v>
                </c:pt>
                <c:pt idx="3">
                  <c:v>4.581081141830488</c:v>
                </c:pt>
              </c:numCache>
            </c:numRef>
          </c:val>
        </c:ser>
        <c:ser>
          <c:idx val="2"/>
          <c:order val="2"/>
          <c:tx>
            <c:strRef>
              <c:f>Hoja1!$A$54</c:f>
              <c:strCache>
                <c:ptCount val="1"/>
                <c:pt idx="0">
                  <c:v>Liposomes</c:v>
                </c:pt>
              </c:strCache>
            </c:strRef>
          </c:tx>
          <c:spPr>
            <a:solidFill>
              <a:schemeClr val="bg1">
                <a:lumMod val="65000"/>
              </a:schemeClr>
            </a:solidFill>
            <a:ln>
              <a:solidFill>
                <a:schemeClr val="tx1"/>
              </a:solidFill>
            </a:ln>
          </c:spPr>
          <c:invertIfNegative val="0"/>
          <c:errBars>
            <c:errBarType val="both"/>
            <c:errValType val="cust"/>
            <c:noEndCap val="0"/>
            <c:plus>
              <c:numRef>
                <c:f>Hoja1!$B$62:$E$62</c:f>
                <c:numCache>
                  <c:formatCode>General</c:formatCode>
                  <c:ptCount val="4"/>
                  <c:pt idx="0">
                    <c:v>0.25886456217874276</c:v>
                  </c:pt>
                  <c:pt idx="1">
                    <c:v>0.25434802823906605</c:v>
                  </c:pt>
                  <c:pt idx="2">
                    <c:v>0.27653921711804613</c:v>
                  </c:pt>
                  <c:pt idx="3">
                    <c:v>0.62503406946865259</c:v>
                  </c:pt>
                </c:numCache>
              </c:numRef>
            </c:plus>
            <c:minus>
              <c:numRef>
                <c:f>Hoja1!$B$62:$E$62</c:f>
                <c:numCache>
                  <c:formatCode>General</c:formatCode>
                  <c:ptCount val="4"/>
                  <c:pt idx="0">
                    <c:v>0.25886456217874276</c:v>
                  </c:pt>
                  <c:pt idx="1">
                    <c:v>0.25434802823906605</c:v>
                  </c:pt>
                  <c:pt idx="2">
                    <c:v>0.27653921711804613</c:v>
                  </c:pt>
                  <c:pt idx="3">
                    <c:v>0.62503406946865259</c:v>
                  </c:pt>
                </c:numCache>
              </c:numRef>
            </c:minus>
          </c:errBars>
          <c:cat>
            <c:strRef>
              <c:f>Hoja1!$B$51:$E$51</c:f>
              <c:strCache>
                <c:ptCount val="4"/>
                <c:pt idx="0">
                  <c:v>rNm-ACPI</c:v>
                </c:pt>
                <c:pt idx="1">
                  <c:v>rNm-ACPII</c:v>
                </c:pt>
                <c:pt idx="2">
                  <c:v>MC58-OM (Nm-ACPI)</c:v>
                </c:pt>
                <c:pt idx="3">
                  <c:v>MC161-OM (Nm-ACPII)</c:v>
                </c:pt>
              </c:strCache>
            </c:strRef>
          </c:cat>
          <c:val>
            <c:numRef>
              <c:f>Hoja1!$B$54:$E$54</c:f>
              <c:numCache>
                <c:formatCode>General</c:formatCode>
                <c:ptCount val="4"/>
                <c:pt idx="0">
                  <c:v>5.1908616721949059</c:v>
                </c:pt>
                <c:pt idx="1">
                  <c:v>5.5380007995640659</c:v>
                </c:pt>
                <c:pt idx="2">
                  <c:v>4.0549007925358467</c:v>
                </c:pt>
                <c:pt idx="3">
                  <c:v>4.0073208751015867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5"/>
        <c:overlap val="-25"/>
        <c:axId val="187346304"/>
        <c:axId val="187356288"/>
      </c:barChart>
      <c:catAx>
        <c:axId val="187346304"/>
        <c:scaling>
          <c:orientation val="minMax"/>
        </c:scaling>
        <c:delete val="0"/>
        <c:axPos val="b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8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356288"/>
        <c:crosses val="autoZero"/>
        <c:auto val="1"/>
        <c:lblAlgn val="ctr"/>
        <c:lblOffset val="100"/>
        <c:noMultiLvlLbl val="0"/>
      </c:catAx>
      <c:valAx>
        <c:axId val="187356288"/>
        <c:scaling>
          <c:orientation val="minMax"/>
          <c:max val="8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A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Log</a:t>
                </a:r>
                <a:r>
                  <a:rPr lang="es-AR" sz="1100" baseline="-25000" dirty="0">
                    <a:latin typeface="Arial" panose="020B0604020202020204" pitchFamily="34" charset="0"/>
                    <a:cs typeface="Arial" panose="020B0604020202020204" pitchFamily="34" charset="0"/>
                  </a:rPr>
                  <a:t>10</a:t>
                </a:r>
                <a:r>
                  <a:rPr lang="es-A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AR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Geomean</a:t>
                </a:r>
                <a:r>
                  <a:rPr lang="es-A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AR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reciprocal</a:t>
                </a:r>
                <a:r>
                  <a:rPr lang="es-A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ELISA </a:t>
                </a:r>
                <a:r>
                  <a:rPr lang="es-AR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titre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  <a:p>
                <a:pPr>
                  <a:defRPr sz="1100">
                    <a:latin typeface="Arial" panose="020B0604020202020204" pitchFamily="34" charset="0"/>
                    <a:cs typeface="Arial" panose="020B0604020202020204" pitchFamily="34" charset="0"/>
                  </a:defRPr>
                </a:pPr>
                <a:r>
                  <a:rPr lang="es-A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(± 95% </a:t>
                </a:r>
                <a:r>
                  <a:rPr lang="es-AR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onfidence</a:t>
                </a:r>
                <a:r>
                  <a:rPr lang="es-A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es-AR" sz="11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limits</a:t>
                </a:r>
                <a:r>
                  <a:rPr lang="es-AR" sz="1100" dirty="0">
                    <a:latin typeface="Arial" panose="020B0604020202020204" pitchFamily="34" charset="0"/>
                    <a:cs typeface="Arial" panose="020B0604020202020204" pitchFamily="34" charset="0"/>
                  </a:rPr>
                  <a:t>)</a:t>
                </a:r>
                <a:endParaRPr lang="en-GB" sz="11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c:rich>
          </c:tx>
          <c:layout/>
          <c:overlay val="0"/>
        </c:title>
        <c:numFmt formatCode="General" sourceLinked="1"/>
        <c:majorTickMark val="out"/>
        <c:minorTickMark val="none"/>
        <c:tickLblPos val="nextTo"/>
        <c:spPr>
          <a:ln w="19050">
            <a:solidFill>
              <a:schemeClr val="tx1"/>
            </a:solidFill>
          </a:ln>
        </c:spPr>
        <c:txPr>
          <a:bodyPr/>
          <a:lstStyle/>
          <a:p>
            <a:pPr>
              <a:defRPr sz="1400">
                <a:latin typeface="Arial" panose="020B0604020202020204" pitchFamily="34" charset="0"/>
                <a:cs typeface="Arial" panose="020B0604020202020204" pitchFamily="34" charset="0"/>
              </a:defRPr>
            </a:pPr>
            <a:endParaRPr lang="en-US"/>
          </a:p>
        </c:txPr>
        <c:crossAx val="187346304"/>
        <c:crosses val="autoZero"/>
        <c:crossBetween val="between"/>
      </c:valAx>
    </c:plotArea>
    <c:legend>
      <c:legendPos val="b"/>
      <c:layout>
        <c:manualLayout>
          <c:xMode val="edge"/>
          <c:yMode val="edge"/>
          <c:x val="0.28294930555555553"/>
          <c:y val="0.8477405498281787"/>
          <c:w val="0.48268039870646351"/>
          <c:h val="6.2181362564653307E-2"/>
        </c:manualLayout>
      </c:layout>
      <c:overlay val="0"/>
      <c:txPr>
        <a:bodyPr/>
        <a:lstStyle/>
        <a:p>
          <a:pPr>
            <a:defRPr>
              <a:latin typeface="Arial" panose="020B0604020202020204" pitchFamily="34" charset="0"/>
              <a:cs typeface="Arial" panose="020B0604020202020204" pitchFamily="34" charset="0"/>
            </a:defRPr>
          </a:pPr>
          <a:endParaRPr lang="en-US"/>
        </a:p>
      </c:txPr>
    </c:legend>
    <c:plotVisOnly val="1"/>
    <c:dispBlanksAs val="gap"/>
    <c:showDLblsOverMax val="0"/>
  </c:chart>
  <c:txPr>
    <a:bodyPr/>
    <a:lstStyle/>
    <a:p>
      <a:pPr>
        <a:defRPr sz="900">
          <a:latin typeface="Times New Roman" panose="02020603050405020304" pitchFamily="18" charset="0"/>
          <a:cs typeface="Times New Roman" panose="02020603050405020304" pitchFamily="18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72E16DA-9413-4692-B45F-30014C867088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9493A55-AFED-413E-A54D-1238B9A153EC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727065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3077282"/>
            <a:ext cx="5829300" cy="2123369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0275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367421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73264"/>
            <a:ext cx="1157288" cy="1220822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5" y="573264"/>
            <a:ext cx="3357563" cy="1220822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553716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2720954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6365523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56688711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257175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2628900" y="3338690"/>
            <a:ext cx="2257425" cy="944280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3817686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3422772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461235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793571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0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107024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858070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AD4CCF-9015-4E70-8B9F-C71B8398A494}" type="datetimeFigureOut">
              <a:rPr lang="en-GB" smtClean="0"/>
              <a:t>03/02/2017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2C570D-FC5A-4F24-B796-F929FD7A2EF1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1865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7" Type="http://schemas.openxmlformats.org/officeDocument/2006/relationships/image" Target="../media/image4.png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.png"/><Relationship Id="rId5" Type="http://schemas.openxmlformats.org/officeDocument/2006/relationships/image" Target="../media/image2.emf"/><Relationship Id="rId4" Type="http://schemas.openxmlformats.org/officeDocument/2006/relationships/image" Target="../media/image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7" name="Char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6233349"/>
              </p:ext>
            </p:extLst>
          </p:nvPr>
        </p:nvGraphicFramePr>
        <p:xfrm>
          <a:off x="125384" y="4070288"/>
          <a:ext cx="3832665" cy="324055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8" name="Chart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96264975"/>
              </p:ext>
            </p:extLst>
          </p:nvPr>
        </p:nvGraphicFramePr>
        <p:xfrm>
          <a:off x="3450605" y="4070288"/>
          <a:ext cx="3832594" cy="32403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pSp>
        <p:nvGrpSpPr>
          <p:cNvPr id="5" name="Group 4"/>
          <p:cNvGrpSpPr/>
          <p:nvPr/>
        </p:nvGrpSpPr>
        <p:grpSpPr>
          <a:xfrm>
            <a:off x="3527401" y="7257911"/>
            <a:ext cx="3285975" cy="2595898"/>
            <a:chOff x="3527401" y="7121744"/>
            <a:chExt cx="3285975" cy="2595898"/>
          </a:xfrm>
        </p:grpSpPr>
        <p:pic>
          <p:nvPicPr>
            <p:cNvPr id="89" name="Picture 2"/>
            <p:cNvPicPr>
              <a:picLocks noChangeAspect="1" noChangeArrowheads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041354" y="8003640"/>
              <a:ext cx="1900259" cy="1252588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101" name="TextBox 100"/>
            <p:cNvSpPr txBox="1"/>
            <p:nvPr/>
          </p:nvSpPr>
          <p:spPr>
            <a:xfrm>
              <a:off x="3612669" y="8883497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102" name="TextBox 101"/>
            <p:cNvSpPr txBox="1"/>
            <p:nvPr/>
          </p:nvSpPr>
          <p:spPr>
            <a:xfrm>
              <a:off x="3612669" y="8594060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103" name="TextBox 102"/>
            <p:cNvSpPr txBox="1"/>
            <p:nvPr/>
          </p:nvSpPr>
          <p:spPr>
            <a:xfrm>
              <a:off x="3612669" y="8450560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104" name="TextBox 103"/>
            <p:cNvSpPr txBox="1"/>
            <p:nvPr/>
          </p:nvSpPr>
          <p:spPr>
            <a:xfrm>
              <a:off x="3612669" y="8299339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105" name="TextBox 104"/>
            <p:cNvSpPr txBox="1"/>
            <p:nvPr/>
          </p:nvSpPr>
          <p:spPr>
            <a:xfrm>
              <a:off x="3612669" y="8210943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106" name="TextBox 105"/>
            <p:cNvSpPr txBox="1"/>
            <p:nvPr/>
          </p:nvSpPr>
          <p:spPr>
            <a:xfrm>
              <a:off x="3527401" y="8076289"/>
              <a:ext cx="576065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107" name="TextBox 106"/>
            <p:cNvSpPr txBox="1"/>
            <p:nvPr/>
          </p:nvSpPr>
          <p:spPr>
            <a:xfrm>
              <a:off x="3527401" y="8013826"/>
              <a:ext cx="576065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108" name="TextBox 107"/>
            <p:cNvSpPr txBox="1"/>
            <p:nvPr/>
          </p:nvSpPr>
          <p:spPr>
            <a:xfrm>
              <a:off x="3612669" y="9078711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109" name="TextBox 108"/>
            <p:cNvSpPr txBox="1"/>
            <p:nvPr/>
          </p:nvSpPr>
          <p:spPr>
            <a:xfrm>
              <a:off x="3527401" y="7939856"/>
              <a:ext cx="576065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</a:p>
          </p:txBody>
        </p:sp>
        <p:sp>
          <p:nvSpPr>
            <p:cNvPr id="110" name="TextBox 109"/>
            <p:cNvSpPr txBox="1"/>
            <p:nvPr/>
          </p:nvSpPr>
          <p:spPr>
            <a:xfrm>
              <a:off x="3612669" y="8145712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111" name="TextBox 110"/>
            <p:cNvSpPr txBox="1"/>
            <p:nvPr/>
          </p:nvSpPr>
          <p:spPr>
            <a:xfrm>
              <a:off x="3682242" y="7755980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8" name="TextBox 127"/>
            <p:cNvSpPr txBox="1"/>
            <p:nvPr/>
          </p:nvSpPr>
          <p:spPr>
            <a:xfrm rot="16200000">
              <a:off x="5533587" y="7639474"/>
              <a:ext cx="612069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NMS</a:t>
              </a:r>
            </a:p>
          </p:txBody>
        </p:sp>
        <p:sp>
          <p:nvSpPr>
            <p:cNvPr id="129" name="TextBox 128"/>
            <p:cNvSpPr txBox="1"/>
            <p:nvPr/>
          </p:nvSpPr>
          <p:spPr>
            <a:xfrm rot="16200000">
              <a:off x="5018394" y="7611635"/>
              <a:ext cx="667746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0" name="TextBox 129"/>
            <p:cNvSpPr txBox="1"/>
            <p:nvPr/>
          </p:nvSpPr>
          <p:spPr>
            <a:xfrm rot="16200000">
              <a:off x="5147078" y="7593094"/>
              <a:ext cx="70482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0H)</a:t>
              </a:r>
              <a:r>
                <a:rPr lang="en-GB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8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1" name="TextBox 130"/>
            <p:cNvSpPr txBox="1"/>
            <p:nvPr/>
          </p:nvSpPr>
          <p:spPr>
            <a:xfrm rot="16200000">
              <a:off x="5180003" y="7479768"/>
              <a:ext cx="93148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32" name="Straight Connector 131"/>
            <p:cNvCxnSpPr/>
            <p:nvPr/>
          </p:nvCxnSpPr>
          <p:spPr>
            <a:xfrm>
              <a:off x="5363828" y="9299774"/>
              <a:ext cx="5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3" name="TextBox 132"/>
            <p:cNvSpPr txBox="1"/>
            <p:nvPr/>
          </p:nvSpPr>
          <p:spPr>
            <a:xfrm>
              <a:off x="4074762" y="7213060"/>
              <a:ext cx="93029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>
              <a:defPPr>
                <a:defRPr lang="en-US"/>
              </a:defPPr>
              <a:lvl1pPr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GB" sz="800" b="1" dirty="0" err="1" smtClean="0"/>
                <a:t>rNm</a:t>
              </a:r>
              <a:r>
                <a:rPr lang="en-GB" sz="800" b="1" dirty="0" smtClean="0"/>
                <a:t>-ACPI</a:t>
              </a:r>
              <a:endParaRPr lang="en-GB" sz="800" b="1" dirty="0"/>
            </a:p>
          </p:txBody>
        </p:sp>
        <p:sp>
          <p:nvSpPr>
            <p:cNvPr id="134" name="TextBox 133"/>
            <p:cNvSpPr txBox="1"/>
            <p:nvPr/>
          </p:nvSpPr>
          <p:spPr>
            <a:xfrm>
              <a:off x="4609840" y="7213060"/>
              <a:ext cx="1004299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>
              <a:defPPr>
                <a:defRPr lang="en-US"/>
              </a:defPPr>
              <a:lvl1pPr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GB" sz="800" b="1" dirty="0" err="1" smtClean="0"/>
                <a:t>rNm</a:t>
              </a:r>
              <a:r>
                <a:rPr lang="en-GB" sz="800" b="1" dirty="0" smtClean="0"/>
                <a:t>-ACPII</a:t>
              </a:r>
              <a:endParaRPr lang="en-GB" sz="800" b="1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5206095" y="9263406"/>
              <a:ext cx="88270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>
              <a:defPPr>
                <a:defRPr lang="en-US"/>
              </a:defPPr>
              <a:lvl1pPr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GB" sz="800" b="1" dirty="0"/>
                <a:t>Controls</a:t>
              </a:r>
            </a:p>
          </p:txBody>
        </p:sp>
        <p:sp>
          <p:nvSpPr>
            <p:cNvPr id="136" name="TextBox 135"/>
            <p:cNvSpPr txBox="1"/>
            <p:nvPr/>
          </p:nvSpPr>
          <p:spPr>
            <a:xfrm rot="16200000">
              <a:off x="4094323" y="7611635"/>
              <a:ext cx="667746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7" name="TextBox 136"/>
            <p:cNvSpPr txBox="1"/>
            <p:nvPr/>
          </p:nvSpPr>
          <p:spPr>
            <a:xfrm rot="16200000">
              <a:off x="4232607" y="7593094"/>
              <a:ext cx="70482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0H)</a:t>
              </a:r>
              <a:r>
                <a:rPr lang="en-GB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8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Box 137"/>
            <p:cNvSpPr txBox="1"/>
            <p:nvPr/>
          </p:nvSpPr>
          <p:spPr>
            <a:xfrm rot="16200000">
              <a:off x="4275057" y="7479768"/>
              <a:ext cx="93148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Box 138"/>
            <p:cNvSpPr txBox="1"/>
            <p:nvPr/>
          </p:nvSpPr>
          <p:spPr>
            <a:xfrm rot="16200000">
              <a:off x="4562702" y="7611635"/>
              <a:ext cx="667746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Box 139"/>
            <p:cNvSpPr txBox="1"/>
            <p:nvPr/>
          </p:nvSpPr>
          <p:spPr>
            <a:xfrm rot="16200000">
              <a:off x="4699938" y="7593094"/>
              <a:ext cx="70482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0H)</a:t>
              </a:r>
              <a:r>
                <a:rPr lang="en-GB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8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Box 140"/>
            <p:cNvSpPr txBox="1"/>
            <p:nvPr/>
          </p:nvSpPr>
          <p:spPr>
            <a:xfrm rot="16200000">
              <a:off x="4730749" y="7479768"/>
              <a:ext cx="93148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42" name="Straight Connector 141"/>
            <p:cNvCxnSpPr/>
            <p:nvPr/>
          </p:nvCxnSpPr>
          <p:spPr>
            <a:xfrm>
              <a:off x="4874630" y="7389083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3" name="Straight Connector 142"/>
            <p:cNvCxnSpPr/>
            <p:nvPr/>
          </p:nvCxnSpPr>
          <p:spPr>
            <a:xfrm>
              <a:off x="4311871" y="7389083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5" name="TextBox 144"/>
            <p:cNvSpPr txBox="1"/>
            <p:nvPr/>
          </p:nvSpPr>
          <p:spPr>
            <a:xfrm>
              <a:off x="4074761" y="9471431"/>
              <a:ext cx="1939437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161-O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6" name="Chevron 145"/>
            <p:cNvSpPr/>
            <p:nvPr/>
          </p:nvSpPr>
          <p:spPr>
            <a:xfrm rot="10800000">
              <a:off x="5976542" y="8919736"/>
              <a:ext cx="84141" cy="144016"/>
            </a:xfrm>
            <a:prstGeom prst="chevron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31" tIns="45715" rIns="91431" bIns="45715" rtlCol="0" anchor="ctr"/>
            <a:lstStyle/>
            <a:p>
              <a:pPr algn="ctr"/>
              <a:endParaRPr lang="en-GB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6014198" y="8808537"/>
              <a:ext cx="799178" cy="400099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m-ACPII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.5 </a:t>
              </a:r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404664" y="7261516"/>
            <a:ext cx="3451552" cy="2592293"/>
            <a:chOff x="404664" y="7125349"/>
            <a:chExt cx="3451552" cy="2592293"/>
          </a:xfrm>
        </p:grpSpPr>
        <p:pic>
          <p:nvPicPr>
            <p:cNvPr id="88" name="Picture 2"/>
            <p:cNvPicPr>
              <a:picLocks noChangeAspect="1" noChangeArrowheads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936705" y="8004087"/>
              <a:ext cx="2035319" cy="1252140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90" name="TextBox 89"/>
            <p:cNvSpPr txBox="1"/>
            <p:nvPr/>
          </p:nvSpPr>
          <p:spPr>
            <a:xfrm>
              <a:off x="489932" y="8791695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5</a:t>
              </a:r>
            </a:p>
          </p:txBody>
        </p:sp>
        <p:sp>
          <p:nvSpPr>
            <p:cNvPr id="91" name="TextBox 90"/>
            <p:cNvSpPr txBox="1"/>
            <p:nvPr/>
          </p:nvSpPr>
          <p:spPr>
            <a:xfrm>
              <a:off x="489932" y="8549883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489932" y="8415908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35</a:t>
              </a:r>
            </a:p>
          </p:txBody>
        </p:sp>
        <p:sp>
          <p:nvSpPr>
            <p:cNvPr id="93" name="TextBox 92"/>
            <p:cNvSpPr txBox="1"/>
            <p:nvPr/>
          </p:nvSpPr>
          <p:spPr>
            <a:xfrm>
              <a:off x="489932" y="8274212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40</a:t>
              </a:r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489932" y="8195341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55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404664" y="8051162"/>
              <a:ext cx="576065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</a:p>
          </p:txBody>
        </p:sp>
        <p:sp>
          <p:nvSpPr>
            <p:cNvPr id="96" name="TextBox 95"/>
            <p:cNvSpPr txBox="1"/>
            <p:nvPr/>
          </p:nvSpPr>
          <p:spPr>
            <a:xfrm>
              <a:off x="404664" y="7988699"/>
              <a:ext cx="576065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30</a:t>
              </a:r>
            </a:p>
          </p:txBody>
        </p:sp>
        <p:sp>
          <p:nvSpPr>
            <p:cNvPr id="97" name="TextBox 96"/>
            <p:cNvSpPr txBox="1"/>
            <p:nvPr/>
          </p:nvSpPr>
          <p:spPr>
            <a:xfrm>
              <a:off x="489932" y="9044059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0</a:t>
              </a:r>
            </a:p>
          </p:txBody>
        </p:sp>
        <p:sp>
          <p:nvSpPr>
            <p:cNvPr id="98" name="TextBox 97"/>
            <p:cNvSpPr txBox="1"/>
            <p:nvPr/>
          </p:nvSpPr>
          <p:spPr>
            <a:xfrm>
              <a:off x="404664" y="7914729"/>
              <a:ext cx="576065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170</a:t>
              </a:r>
            </a:p>
          </p:txBody>
        </p:sp>
        <p:sp>
          <p:nvSpPr>
            <p:cNvPr id="99" name="TextBox 98"/>
            <p:cNvSpPr txBox="1"/>
            <p:nvPr/>
          </p:nvSpPr>
          <p:spPr>
            <a:xfrm>
              <a:off x="489932" y="8120585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700" dirty="0">
                  <a:latin typeface="Arial" panose="020B0604020202020204" pitchFamily="34" charset="0"/>
                  <a:cs typeface="Arial" panose="020B0604020202020204" pitchFamily="34" charset="0"/>
                </a:rPr>
                <a:t>70</a:t>
              </a:r>
            </a:p>
          </p:txBody>
        </p:sp>
        <p:sp>
          <p:nvSpPr>
            <p:cNvPr id="100" name="TextBox 99"/>
            <p:cNvSpPr txBox="1"/>
            <p:nvPr/>
          </p:nvSpPr>
          <p:spPr>
            <a:xfrm>
              <a:off x="559505" y="7768953"/>
              <a:ext cx="490797" cy="200045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7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7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2" name="TextBox 111"/>
            <p:cNvSpPr txBox="1"/>
            <p:nvPr/>
          </p:nvSpPr>
          <p:spPr>
            <a:xfrm rot="16200000">
              <a:off x="2598441" y="7643079"/>
              <a:ext cx="612069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>
                  <a:latin typeface="Arial" panose="020B0604020202020204" pitchFamily="34" charset="0"/>
                  <a:cs typeface="Arial" panose="020B0604020202020204" pitchFamily="34" charset="0"/>
                </a:rPr>
                <a:t>NMS</a:t>
              </a:r>
            </a:p>
          </p:txBody>
        </p:sp>
        <p:sp>
          <p:nvSpPr>
            <p:cNvPr id="113" name="TextBox 112"/>
            <p:cNvSpPr txBox="1"/>
            <p:nvPr/>
          </p:nvSpPr>
          <p:spPr>
            <a:xfrm rot="16200000">
              <a:off x="2054673" y="7615240"/>
              <a:ext cx="667746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4" name="TextBox 113"/>
            <p:cNvSpPr txBox="1"/>
            <p:nvPr/>
          </p:nvSpPr>
          <p:spPr>
            <a:xfrm rot="16200000">
              <a:off x="2183357" y="7596699"/>
              <a:ext cx="70482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0H)</a:t>
              </a:r>
              <a:r>
                <a:rPr lang="en-GB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8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15" name="TextBox 114"/>
            <p:cNvSpPr txBox="1"/>
            <p:nvPr/>
          </p:nvSpPr>
          <p:spPr>
            <a:xfrm rot="16200000">
              <a:off x="2244857" y="7483373"/>
              <a:ext cx="93148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16" name="Straight Connector 115"/>
            <p:cNvCxnSpPr/>
            <p:nvPr/>
          </p:nvCxnSpPr>
          <p:spPr>
            <a:xfrm>
              <a:off x="2400107" y="9299774"/>
              <a:ext cx="540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17" name="TextBox 116"/>
            <p:cNvSpPr txBox="1"/>
            <p:nvPr/>
          </p:nvSpPr>
          <p:spPr>
            <a:xfrm>
              <a:off x="1034841" y="7213060"/>
              <a:ext cx="93029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>
              <a:defPPr>
                <a:defRPr lang="en-US"/>
              </a:defPPr>
              <a:lvl1pPr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GB" sz="800" b="1" dirty="0" err="1" smtClean="0"/>
                <a:t>rNm</a:t>
              </a:r>
              <a:r>
                <a:rPr lang="en-GB" sz="800" b="1" dirty="0" smtClean="0"/>
                <a:t>-ACPI</a:t>
              </a:r>
              <a:endParaRPr lang="en-GB" sz="800" b="1" dirty="0"/>
            </a:p>
          </p:txBody>
        </p:sp>
        <p:sp>
          <p:nvSpPr>
            <p:cNvPr id="118" name="TextBox 117"/>
            <p:cNvSpPr txBox="1"/>
            <p:nvPr/>
          </p:nvSpPr>
          <p:spPr>
            <a:xfrm>
              <a:off x="1569919" y="7213060"/>
              <a:ext cx="1004299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>
              <a:defPPr>
                <a:defRPr lang="en-US"/>
              </a:defPPr>
              <a:lvl1pPr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GB" sz="800" b="1" dirty="0" err="1" smtClean="0"/>
                <a:t>rNm</a:t>
              </a:r>
              <a:r>
                <a:rPr lang="en-GB" sz="800" b="1" dirty="0" smtClean="0"/>
                <a:t>-ACPII</a:t>
              </a:r>
              <a:endParaRPr lang="en-GB" sz="800" b="1" dirty="0"/>
            </a:p>
          </p:txBody>
        </p:sp>
        <p:sp>
          <p:nvSpPr>
            <p:cNvPr id="119" name="TextBox 118"/>
            <p:cNvSpPr txBox="1"/>
            <p:nvPr/>
          </p:nvSpPr>
          <p:spPr>
            <a:xfrm>
              <a:off x="2247011" y="9263406"/>
              <a:ext cx="88270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>
              <a:defPPr>
                <a:defRPr lang="en-US"/>
              </a:defPPr>
              <a:lvl1pPr>
                <a:defRPr sz="1200">
                  <a:latin typeface="Arial" panose="020B0604020202020204" pitchFamily="34" charset="0"/>
                  <a:cs typeface="Arial" panose="020B0604020202020204" pitchFamily="34" charset="0"/>
                </a:defRPr>
              </a:lvl1pPr>
            </a:lstStyle>
            <a:p>
              <a:pPr algn="ctr"/>
              <a:r>
                <a:rPr lang="en-GB" sz="800" b="1" dirty="0"/>
                <a:t>Controls</a:t>
              </a:r>
            </a:p>
          </p:txBody>
        </p:sp>
        <p:sp>
          <p:nvSpPr>
            <p:cNvPr id="120" name="TextBox 119"/>
            <p:cNvSpPr txBox="1"/>
            <p:nvPr/>
          </p:nvSpPr>
          <p:spPr>
            <a:xfrm rot="16200000">
              <a:off x="1006777" y="7615240"/>
              <a:ext cx="667746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1" name="TextBox 120"/>
            <p:cNvSpPr txBox="1"/>
            <p:nvPr/>
          </p:nvSpPr>
          <p:spPr>
            <a:xfrm rot="16200000">
              <a:off x="1145061" y="7596699"/>
              <a:ext cx="70482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0H)</a:t>
              </a:r>
              <a:r>
                <a:rPr lang="en-GB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8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2" name="TextBox 121"/>
            <p:cNvSpPr txBox="1"/>
            <p:nvPr/>
          </p:nvSpPr>
          <p:spPr>
            <a:xfrm rot="16200000">
              <a:off x="1216086" y="7483373"/>
              <a:ext cx="93148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3" name="TextBox 122"/>
            <p:cNvSpPr txBox="1"/>
            <p:nvPr/>
          </p:nvSpPr>
          <p:spPr>
            <a:xfrm rot="16200000">
              <a:off x="1541831" y="7615240"/>
              <a:ext cx="667746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4" name="TextBox 123"/>
            <p:cNvSpPr txBox="1"/>
            <p:nvPr/>
          </p:nvSpPr>
          <p:spPr>
            <a:xfrm rot="16200000">
              <a:off x="1679067" y="7596699"/>
              <a:ext cx="704828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0H)</a:t>
              </a:r>
              <a:r>
                <a:rPr lang="en-GB" sz="800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800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25" name="TextBox 124"/>
            <p:cNvSpPr txBox="1"/>
            <p:nvPr/>
          </p:nvSpPr>
          <p:spPr>
            <a:xfrm rot="16200000">
              <a:off x="1747978" y="7483373"/>
              <a:ext cx="931481" cy="215433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8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  <a:endParaRPr lang="en-GB" sz="8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cxnSp>
          <p:nvCxnSpPr>
            <p:cNvPr id="126" name="Straight Connector 125"/>
            <p:cNvCxnSpPr/>
            <p:nvPr/>
          </p:nvCxnSpPr>
          <p:spPr>
            <a:xfrm>
              <a:off x="1834709" y="7389083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27" name="Straight Connector 126"/>
            <p:cNvCxnSpPr/>
            <p:nvPr/>
          </p:nvCxnSpPr>
          <p:spPr>
            <a:xfrm>
              <a:off x="1271950" y="7389083"/>
              <a:ext cx="4320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4" name="TextBox 143"/>
            <p:cNvSpPr txBox="1"/>
            <p:nvPr/>
          </p:nvSpPr>
          <p:spPr>
            <a:xfrm>
              <a:off x="1168232" y="9471431"/>
              <a:ext cx="1889250" cy="246211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r"/>
              <a:r>
                <a:rPr lang="en-GB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C58-OM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1" name="Chevron 150"/>
            <p:cNvSpPr/>
            <p:nvPr/>
          </p:nvSpPr>
          <p:spPr>
            <a:xfrm rot="10800000">
              <a:off x="3019382" y="8919736"/>
              <a:ext cx="84141" cy="144016"/>
            </a:xfrm>
            <a:prstGeom prst="chevron">
              <a:avLst/>
            </a:prstGeom>
            <a:solidFill>
              <a:schemeClr val="tx1"/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lIns="91431" tIns="45715" rIns="91431" bIns="45715" rtlCol="0" anchor="ctr"/>
            <a:lstStyle/>
            <a:p>
              <a:pPr algn="ctr"/>
              <a:endParaRPr lang="en-GB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2" name="TextBox 151"/>
            <p:cNvSpPr txBox="1"/>
            <p:nvPr/>
          </p:nvSpPr>
          <p:spPr>
            <a:xfrm>
              <a:off x="3057038" y="8808537"/>
              <a:ext cx="799178" cy="400099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m-ACPI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  <a:p>
              <a:r>
                <a:rPr lang="en-GB" sz="10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11.5 </a:t>
              </a:r>
              <a:r>
                <a:rPr lang="en-GB" sz="10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GB" sz="10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sp>
        <p:nvSpPr>
          <p:cNvPr id="155" name="TextBox 154"/>
          <p:cNvSpPr txBox="1"/>
          <p:nvPr/>
        </p:nvSpPr>
        <p:spPr>
          <a:xfrm>
            <a:off x="34092" y="3805003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B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6" name="TextBox 155"/>
          <p:cNvSpPr txBox="1"/>
          <p:nvPr/>
        </p:nvSpPr>
        <p:spPr>
          <a:xfrm>
            <a:off x="34092" y="7180573"/>
            <a:ext cx="373820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b="1" dirty="0" smtClean="0">
                <a:latin typeface="Arial" panose="020B0604020202020204" pitchFamily="34" charset="0"/>
                <a:cs typeface="Arial" panose="020B0604020202020204" pitchFamily="34" charset="0"/>
              </a:rPr>
              <a:t>C)</a:t>
            </a:r>
            <a:endParaRPr lang="en-GB" sz="14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Group 2"/>
          <p:cNvGrpSpPr/>
          <p:nvPr/>
        </p:nvGrpSpPr>
        <p:grpSpPr>
          <a:xfrm>
            <a:off x="-72223" y="1157"/>
            <a:ext cx="7177402" cy="3889794"/>
            <a:chOff x="-72223" y="1157"/>
            <a:chExt cx="7177402" cy="3889794"/>
          </a:xfrm>
        </p:grpSpPr>
        <p:pic>
          <p:nvPicPr>
            <p:cNvPr id="1029" name="Picture 5"/>
            <p:cNvPicPr>
              <a:picLocks noChangeAspect="1" noChangeArrowheads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11746" y="487979"/>
              <a:ext cx="2934270" cy="3402972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8" name="TextBox 7"/>
            <p:cNvSpPr txBox="1"/>
            <p:nvPr/>
          </p:nvSpPr>
          <p:spPr>
            <a:xfrm>
              <a:off x="-72223" y="526078"/>
              <a:ext cx="1152128" cy="3693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C58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m-ACPI)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9" name="TextBox 8"/>
            <p:cNvSpPr txBox="1"/>
            <p:nvPr/>
          </p:nvSpPr>
          <p:spPr>
            <a:xfrm>
              <a:off x="-72223" y="1334013"/>
              <a:ext cx="1134415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C58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acpI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541323" y="315906"/>
              <a:ext cx="1368152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1594892" y="315906"/>
              <a:ext cx="1368152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OH)</a:t>
              </a:r>
              <a:r>
                <a:rPr lang="en-GB" sz="9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627938" y="315906"/>
              <a:ext cx="1368152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-72223" y="2291807"/>
              <a:ext cx="1152128" cy="3693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C161 </a:t>
              </a:r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WT</a:t>
              </a:r>
            </a:p>
            <a:p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Nm-ACPII)</a:t>
              </a:r>
              <a:endParaRPr lang="en-GB" sz="9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-72223" y="3097326"/>
              <a:ext cx="1227380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MC161</a:t>
              </a:r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</a:t>
              </a:r>
              <a:r>
                <a:rPr lang="en-GB" sz="900" b="1" i="1" dirty="0" smtClean="0">
                  <a:latin typeface="Arial" panose="020B0604020202020204" pitchFamily="34" charset="0"/>
                  <a:cs typeface="Arial" panose="020B0604020202020204" pitchFamily="34" charset="0"/>
                  <a:sym typeface="Symbol"/>
                </a:rPr>
                <a:t>acpII</a:t>
              </a:r>
              <a:endParaRPr lang="en-GB" sz="900" b="1" i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1030" name="Picture 6"/>
            <p:cNvPicPr>
              <a:picLocks noChangeAspect="1" noChangeArrowheads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844983" y="487896"/>
              <a:ext cx="2898717" cy="34020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31" name="TextBox 30"/>
            <p:cNvSpPr txBox="1"/>
            <p:nvPr/>
          </p:nvSpPr>
          <p:spPr>
            <a:xfrm>
              <a:off x="3663291" y="315906"/>
              <a:ext cx="1368152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Saline</a:t>
              </a:r>
            </a:p>
          </p:txBody>
        </p:sp>
        <p:sp>
          <p:nvSpPr>
            <p:cNvPr id="32" name="TextBox 31"/>
            <p:cNvSpPr txBox="1"/>
            <p:nvPr/>
          </p:nvSpPr>
          <p:spPr>
            <a:xfrm>
              <a:off x="4716860" y="315906"/>
              <a:ext cx="1368152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l(OH)</a:t>
              </a:r>
              <a:r>
                <a:rPr lang="en-GB" sz="900" b="1" baseline="-25000" dirty="0" smtClean="0">
                  <a:latin typeface="Arial" panose="020B0604020202020204" pitchFamily="34" charset="0"/>
                  <a:cs typeface="Arial" panose="020B0604020202020204" pitchFamily="34" charset="0"/>
                </a:rPr>
                <a:t>3</a:t>
              </a:r>
              <a:endParaRPr lang="en-GB" sz="900" b="1" baseline="-25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3" name="TextBox 32"/>
            <p:cNvSpPr txBox="1"/>
            <p:nvPr/>
          </p:nvSpPr>
          <p:spPr>
            <a:xfrm>
              <a:off x="5737027" y="315906"/>
              <a:ext cx="1368152" cy="230822"/>
            </a:xfrm>
            <a:prstGeom prst="rect">
              <a:avLst/>
            </a:prstGeom>
            <a:noFill/>
          </p:spPr>
          <p:txBody>
            <a:bodyPr wrap="square" lIns="91431" tIns="45715" rIns="91431" bIns="45715" rtlCol="0">
              <a:spAutoFit/>
            </a:bodyPr>
            <a:lstStyle/>
            <a:p>
              <a:pPr algn="ctr"/>
              <a:r>
                <a:rPr lang="en-GB" sz="900" b="1" dirty="0">
                  <a:latin typeface="Arial" panose="020B0604020202020204" pitchFamily="34" charset="0"/>
                  <a:cs typeface="Arial" panose="020B0604020202020204" pitchFamily="34" charset="0"/>
                </a:rPr>
                <a:t>Liposomes</a:t>
              </a:r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1225399" y="61802"/>
              <a:ext cx="1953669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use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era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GB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Nm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PI</a:t>
              </a:r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4221089" y="61802"/>
              <a:ext cx="2200014" cy="26161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Mouse </a:t>
              </a:r>
              <a:r>
                <a:rPr lang="en-GB" sz="1100" b="1" dirty="0">
                  <a:latin typeface="Arial" panose="020B0604020202020204" pitchFamily="34" charset="0"/>
                  <a:cs typeface="Arial" panose="020B0604020202020204" pitchFamily="34" charset="0"/>
                </a:rPr>
                <a:t>sera 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nti-</a:t>
              </a:r>
              <a:r>
                <a:rPr lang="en-GB" sz="11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rNm</a:t>
              </a:r>
              <a:r>
                <a:rPr lang="en-GB" sz="11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ACPII</a:t>
              </a:r>
              <a:endParaRPr lang="en-GB" sz="11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4" name="TextBox 153"/>
            <p:cNvSpPr txBox="1"/>
            <p:nvPr/>
          </p:nvSpPr>
          <p:spPr>
            <a:xfrm>
              <a:off x="34092" y="1157"/>
              <a:ext cx="373820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14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A)</a:t>
              </a:r>
              <a:endParaRPr lang="en-GB" sz="14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" name="TextBox 1"/>
            <p:cNvSpPr txBox="1"/>
            <p:nvPr/>
          </p:nvSpPr>
          <p:spPr>
            <a:xfrm>
              <a:off x="1169542" y="52660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6" name="TextBox 85"/>
            <p:cNvSpPr txBox="1"/>
            <p:nvPr/>
          </p:nvSpPr>
          <p:spPr>
            <a:xfrm>
              <a:off x="2253630" y="52660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87" name="TextBox 86"/>
            <p:cNvSpPr txBox="1"/>
            <p:nvPr/>
          </p:nvSpPr>
          <p:spPr>
            <a:xfrm>
              <a:off x="3342134" y="52660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4350246" y="52660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5378549" y="52660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0" name="TextBox 149"/>
            <p:cNvSpPr txBox="1"/>
            <p:nvPr/>
          </p:nvSpPr>
          <p:spPr>
            <a:xfrm>
              <a:off x="6400378" y="526604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3" name="TextBox 152"/>
            <p:cNvSpPr txBox="1"/>
            <p:nvPr/>
          </p:nvSpPr>
          <p:spPr>
            <a:xfrm>
              <a:off x="1255267" y="233364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7" name="TextBox 156"/>
            <p:cNvSpPr txBox="1"/>
            <p:nvPr/>
          </p:nvSpPr>
          <p:spPr>
            <a:xfrm>
              <a:off x="2320305" y="233364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8" name="TextBox 157"/>
            <p:cNvSpPr txBox="1"/>
            <p:nvPr/>
          </p:nvSpPr>
          <p:spPr>
            <a:xfrm>
              <a:off x="3351659" y="233364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59" name="TextBox 158"/>
            <p:cNvSpPr txBox="1"/>
            <p:nvPr/>
          </p:nvSpPr>
          <p:spPr>
            <a:xfrm>
              <a:off x="4321671" y="233364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0" name="TextBox 159"/>
            <p:cNvSpPr txBox="1"/>
            <p:nvPr/>
          </p:nvSpPr>
          <p:spPr>
            <a:xfrm>
              <a:off x="5416649" y="233364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61" name="TextBox 160"/>
            <p:cNvSpPr txBox="1"/>
            <p:nvPr/>
          </p:nvSpPr>
          <p:spPr>
            <a:xfrm>
              <a:off x="6467053" y="2333645"/>
              <a:ext cx="144016" cy="27699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12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*</a:t>
              </a:r>
              <a:endParaRPr lang="en-GB" sz="12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3380017336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50</TotalTime>
  <Words>128</Words>
  <Application>Microsoft Office PowerPoint</Application>
  <PresentationFormat>A4 Paper (210x297 mm)</PresentationFormat>
  <Paragraphs>89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University of Southampton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umbert M.V.</dc:creator>
  <cp:lastModifiedBy>Humbert M.V.</cp:lastModifiedBy>
  <cp:revision>16</cp:revision>
  <dcterms:created xsi:type="dcterms:W3CDTF">2016-06-11T16:10:42Z</dcterms:created>
  <dcterms:modified xsi:type="dcterms:W3CDTF">2017-02-03T14:27:21Z</dcterms:modified>
</cp:coreProperties>
</file>